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7053263" cy="93091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1" d="100"/>
          <a:sy n="91" d="100"/>
        </p:scale>
        <p:origin x="-1517" y="-8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D00F4-91F2-4B42-AA7E-1DE11A117B22}" type="datetimeFigureOut">
              <a:rPr lang="zh-CN" altLang="en-US" smtClean="0"/>
              <a:t>2015/9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4789BB-53F7-455F-AB18-44CE93BDF38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2373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D00F4-91F2-4B42-AA7E-1DE11A117B22}" type="datetimeFigureOut">
              <a:rPr lang="zh-CN" altLang="en-US" smtClean="0"/>
              <a:t>2015/9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4789BB-53F7-455F-AB18-44CE93BDF38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039195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D00F4-91F2-4B42-AA7E-1DE11A117B22}" type="datetimeFigureOut">
              <a:rPr lang="zh-CN" altLang="en-US" smtClean="0"/>
              <a:t>2015/9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4789BB-53F7-455F-AB18-44CE93BDF38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54900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D00F4-91F2-4B42-AA7E-1DE11A117B22}" type="datetimeFigureOut">
              <a:rPr lang="zh-CN" altLang="en-US" smtClean="0"/>
              <a:t>2015/9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4789BB-53F7-455F-AB18-44CE93BDF38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969231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D00F4-91F2-4B42-AA7E-1DE11A117B22}" type="datetimeFigureOut">
              <a:rPr lang="zh-CN" altLang="en-US" smtClean="0"/>
              <a:t>2015/9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4789BB-53F7-455F-AB18-44CE93BDF38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371338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D00F4-91F2-4B42-AA7E-1DE11A117B22}" type="datetimeFigureOut">
              <a:rPr lang="zh-CN" altLang="en-US" smtClean="0"/>
              <a:t>2015/9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4789BB-53F7-455F-AB18-44CE93BDF38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784619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D00F4-91F2-4B42-AA7E-1DE11A117B22}" type="datetimeFigureOut">
              <a:rPr lang="zh-CN" altLang="en-US" smtClean="0"/>
              <a:t>2015/9/2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4789BB-53F7-455F-AB18-44CE93BDF38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54381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D00F4-91F2-4B42-AA7E-1DE11A117B22}" type="datetimeFigureOut">
              <a:rPr lang="zh-CN" altLang="en-US" smtClean="0"/>
              <a:t>2015/9/2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4789BB-53F7-455F-AB18-44CE93BDF38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97771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D00F4-91F2-4B42-AA7E-1DE11A117B22}" type="datetimeFigureOut">
              <a:rPr lang="zh-CN" altLang="en-US" smtClean="0"/>
              <a:t>2015/9/2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4789BB-53F7-455F-AB18-44CE93BDF38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230052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D00F4-91F2-4B42-AA7E-1DE11A117B22}" type="datetimeFigureOut">
              <a:rPr lang="zh-CN" altLang="en-US" smtClean="0"/>
              <a:t>2015/9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4789BB-53F7-455F-AB18-44CE93BDF38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59720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D00F4-91F2-4B42-AA7E-1DE11A117B22}" type="datetimeFigureOut">
              <a:rPr lang="zh-CN" altLang="en-US" smtClean="0"/>
              <a:t>2015/9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4789BB-53F7-455F-AB18-44CE93BDF38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807058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5D00F4-91F2-4B42-AA7E-1DE11A117B22}" type="datetimeFigureOut">
              <a:rPr lang="zh-CN" altLang="en-US" smtClean="0"/>
              <a:t>2015/9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4789BB-53F7-455F-AB18-44CE93BDF38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71863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34" name="Rectangle 4"/>
          <p:cNvSpPr>
            <a:spLocks noChangeArrowheads="1"/>
          </p:cNvSpPr>
          <p:nvPr/>
        </p:nvSpPr>
        <p:spPr bwMode="auto">
          <a:xfrm>
            <a:off x="1115838" y="303039"/>
            <a:ext cx="684053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CA" altLang="zh-CN" sz="1200" b="1" dirty="0" smtClean="0">
                <a:latin typeface="Arial" charset="0"/>
              </a:rPr>
              <a:t>S1 Table. </a:t>
            </a:r>
            <a:r>
              <a:rPr lang="en-CA" altLang="zh-CN" sz="1200" b="1" dirty="0">
                <a:latin typeface="Arial" charset="0"/>
              </a:rPr>
              <a:t>Sequences of Oligonucleotide Primers Used </a:t>
            </a:r>
            <a:r>
              <a:rPr lang="en-CA" altLang="zh-CN" sz="1200" b="1" dirty="0" smtClean="0">
                <a:latin typeface="Arial" charset="0"/>
              </a:rPr>
              <a:t>to </a:t>
            </a:r>
            <a:r>
              <a:rPr lang="en-CA" altLang="zh-CN" sz="1200" b="1" dirty="0">
                <a:latin typeface="Arial" charset="0"/>
              </a:rPr>
              <a:t>Amplify HCV Genome Fragments</a:t>
            </a:r>
          </a:p>
        </p:txBody>
      </p:sp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48694413"/>
              </p:ext>
            </p:extLst>
          </p:nvPr>
        </p:nvGraphicFramePr>
        <p:xfrm>
          <a:off x="1363595" y="998538"/>
          <a:ext cx="6480175" cy="4919668"/>
        </p:xfrm>
        <a:graphic>
          <a:graphicData uri="http://schemas.openxmlformats.org/drawingml/2006/table">
            <a:tbl>
              <a:tblPr/>
              <a:tblGrid>
                <a:gridCol w="1552221"/>
                <a:gridCol w="3699229"/>
                <a:gridCol w="1228725"/>
              </a:tblGrid>
              <a:tr h="192088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Primer</a:t>
                      </a: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Sequence</a:t>
                      </a: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altLang="zh-CN" sz="12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Amplicon</a:t>
                      </a:r>
                      <a:r>
                        <a:rPr kumimoji="0" lang="en-CA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 (</a:t>
                      </a:r>
                      <a:r>
                        <a:rPr kumimoji="0" lang="en-CA" altLang="zh-CN" sz="12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bp</a:t>
                      </a:r>
                      <a:r>
                        <a:rPr kumimoji="0" lang="en-CA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)</a:t>
                      </a: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00048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altLang="zh-CN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5ʹ-UTR</a:t>
                      </a: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altLang="zh-CN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altLang="zh-CN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7488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en-US" sz="1200" b="0" i="1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   </a:t>
                      </a:r>
                      <a:r>
                        <a:rPr kumimoji="0" lang="en-CA" altLang="zh-CN" sz="1200" b="0" i="1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External primers</a:t>
                      </a: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altLang="zh-CN" sz="12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altLang="zh-CN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92088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      </a:t>
                      </a:r>
                      <a:r>
                        <a:rPr kumimoji="0" lang="en-CA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sense</a:t>
                      </a: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5’-CTGTGAGGAACTACTGTCTTC                        </a:t>
                      </a: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346</a:t>
                      </a: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92088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      </a:t>
                      </a:r>
                      <a:r>
                        <a:rPr kumimoji="0" lang="en-CA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antisense</a:t>
                      </a: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5’-GCGGTTGGTGTTACGTTT                                   </a:t>
                      </a: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92088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en-US" sz="1200" b="0" i="1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   </a:t>
                      </a:r>
                      <a:r>
                        <a:rPr kumimoji="0" lang="en-CA" altLang="zh-CN" sz="1200" b="0" i="1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Nested primers</a:t>
                      </a: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altLang="zh-CN" sz="12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altLang="zh-CN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92088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      </a:t>
                      </a:r>
                      <a:r>
                        <a:rPr kumimoji="0" lang="en-CA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sense</a:t>
                      </a: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5’-GCAGAAAGCGTCTAGCCATGGCGT                   </a:t>
                      </a: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244</a:t>
                      </a: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92088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      </a:t>
                      </a:r>
                      <a:r>
                        <a:rPr kumimoji="0" lang="en-CA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antisense</a:t>
                      </a: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5’-CTCGCAAGCACCCTATGAGGCAGT                 </a:t>
                      </a: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338136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altLang="zh-CN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E1/E2 region</a:t>
                      </a: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altLang="zh-CN" sz="12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altLang="zh-CN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590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Genotype 1b</a:t>
                      </a: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altLang="zh-CN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altLang="zh-CN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92088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en-US" sz="1200" b="0" i="1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   </a:t>
                      </a:r>
                      <a:r>
                        <a:rPr kumimoji="0" lang="en-CA" altLang="zh-CN" sz="1200" b="0" i="1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External primers</a:t>
                      </a: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altLang="zh-CN" sz="12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altLang="zh-CN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92088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      </a:t>
                      </a:r>
                      <a:r>
                        <a:rPr kumimoji="0" lang="en-CA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sense</a:t>
                      </a: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5’-TGGGATATGATGATGAAYTGGT</a:t>
                      </a: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549</a:t>
                      </a: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92088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      </a:t>
                      </a:r>
                      <a:r>
                        <a:rPr kumimoji="0" lang="en-CA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antisense</a:t>
                      </a: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5’-ATACCACACTGCCGAGGTGCGT</a:t>
                      </a: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altLang="zh-CN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92088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en-US" sz="1200" b="0" i="1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   </a:t>
                      </a:r>
                      <a:r>
                        <a:rPr kumimoji="0" lang="en-CA" altLang="zh-CN" sz="1200" b="0" i="1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Nested primers</a:t>
                      </a: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altLang="zh-CN" sz="12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altLang="zh-CN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92088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en-US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      </a:t>
                      </a:r>
                      <a:r>
                        <a:rPr kumimoji="0" lang="en-CA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sense</a:t>
                      </a: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5’-TGGGATATGATGATGAAYTGGT</a:t>
                      </a: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452</a:t>
                      </a: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92088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      </a:t>
                      </a:r>
                      <a:r>
                        <a:rPr kumimoji="0" lang="en-CA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antisense</a:t>
                      </a: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5’-ATGGGGCCCCATCCCTGAGCGA</a:t>
                      </a: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altLang="zh-CN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90512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Genotype 3a</a:t>
                      </a: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altLang="zh-CN" sz="12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altLang="zh-CN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92088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en-US" sz="1200" b="0" i="1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   </a:t>
                      </a:r>
                      <a:r>
                        <a:rPr kumimoji="0" lang="en-CA" altLang="zh-CN" sz="1200" b="0" i="1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External primers</a:t>
                      </a: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altLang="zh-CN" sz="12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altLang="zh-CN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92088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      </a:t>
                      </a:r>
                      <a:r>
                        <a:rPr kumimoji="0" lang="en-CA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sense</a:t>
                      </a: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5’-TATGGTGGTGGCGCATGTCCT                                    </a:t>
                      </a: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514</a:t>
                      </a: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92088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      </a:t>
                      </a:r>
                      <a:r>
                        <a:rPr kumimoji="0" lang="en-CA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antisense</a:t>
                      </a: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5’-ATGTCACAAGGTCTAGGTGCGT</a:t>
                      </a: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altLang="zh-CN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92088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en-US" sz="1200" b="0" i="1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   </a:t>
                      </a:r>
                      <a:r>
                        <a:rPr kumimoji="0" lang="en-CA" altLang="zh-CN" sz="1200" b="0" i="1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Nested primers</a:t>
                      </a: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altLang="zh-CN" sz="12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altLang="zh-CN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92088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      </a:t>
                      </a:r>
                      <a:r>
                        <a:rPr kumimoji="0" lang="en-CA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sense</a:t>
                      </a: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5’-TATGGTGGTGGCGCATGTCCT                                    </a:t>
                      </a: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448</a:t>
                      </a: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92088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      </a:t>
                      </a:r>
                      <a:r>
                        <a:rPr kumimoji="0" lang="en-CA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antisense</a:t>
                      </a: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5’-TAGCATCTGTTAAGGGGCCCCAT</a:t>
                      </a: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altLang="zh-CN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8683" marR="8683" marT="8684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cxnSp>
        <p:nvCxnSpPr>
          <p:cNvPr id="10" name="Straight Connector 9"/>
          <p:cNvCxnSpPr/>
          <p:nvPr/>
        </p:nvCxnSpPr>
        <p:spPr>
          <a:xfrm>
            <a:off x="1228725" y="885825"/>
            <a:ext cx="655161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>
            <a:off x="1238250" y="6029325"/>
            <a:ext cx="65532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1238250" y="1330393"/>
            <a:ext cx="65532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507" name="TextBox 15"/>
          <p:cNvSpPr txBox="1">
            <a:spLocks noChangeArrowheads="1"/>
          </p:cNvSpPr>
          <p:nvPr/>
        </p:nvSpPr>
        <p:spPr bwMode="auto">
          <a:xfrm>
            <a:off x="468313" y="5013325"/>
            <a:ext cx="184150" cy="646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en-US" altLang="zh-CN" sz="1800">
              <a:latin typeface="Arial" charset="0"/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endParaRPr lang="en-CA" altLang="zh-CN" sz="1800">
              <a:latin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353343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113</Words>
  <Application>Microsoft Office PowerPoint</Application>
  <PresentationFormat>On-screen Show (4:3)</PresentationFormat>
  <Paragraphs>4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主题​​</vt:lpstr>
      <vt:lpstr>PowerPoint Presentation</vt:lpstr>
    </vt:vector>
  </TitlesOfParts>
  <Company>chin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nnie</dc:creator>
  <cp:lastModifiedBy>Michalak, Thomas</cp:lastModifiedBy>
  <cp:revision>8</cp:revision>
  <cp:lastPrinted>2015-01-20T19:04:44Z</cp:lastPrinted>
  <dcterms:created xsi:type="dcterms:W3CDTF">2015-01-14T20:03:09Z</dcterms:created>
  <dcterms:modified xsi:type="dcterms:W3CDTF">2015-09-24T13:51:48Z</dcterms:modified>
</cp:coreProperties>
</file>